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43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80" d="100"/>
          <a:sy n="80" d="100"/>
        </p:scale>
        <p:origin x="3066" y="114"/>
      </p:cViewPr>
      <p:guideLst>
        <p:guide orient="horz" pos="3143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C2A0EA-36B1-42F2-A831-AFCC2032E692}" type="datetimeFigureOut">
              <a:rPr lang="en-GB" smtClean="0"/>
              <a:t>16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E2C32-EBFB-485C-92F4-904749EA93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73328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C2A0EA-36B1-42F2-A831-AFCC2032E692}" type="datetimeFigureOut">
              <a:rPr lang="en-GB" smtClean="0"/>
              <a:t>16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E2C32-EBFB-485C-92F4-904749EA93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235463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C2A0EA-36B1-42F2-A831-AFCC2032E692}" type="datetimeFigureOut">
              <a:rPr lang="en-GB" smtClean="0"/>
              <a:t>16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E2C32-EBFB-485C-92F4-904749EA93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17590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C2A0EA-36B1-42F2-A831-AFCC2032E692}" type="datetimeFigureOut">
              <a:rPr lang="en-GB" smtClean="0"/>
              <a:t>16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E2C32-EBFB-485C-92F4-904749EA93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03464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C2A0EA-36B1-42F2-A831-AFCC2032E692}" type="datetimeFigureOut">
              <a:rPr lang="en-GB" smtClean="0"/>
              <a:t>16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E2C32-EBFB-485C-92F4-904749EA93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641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C2A0EA-36B1-42F2-A831-AFCC2032E692}" type="datetimeFigureOut">
              <a:rPr lang="en-GB" smtClean="0"/>
              <a:t>16/02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E2C32-EBFB-485C-92F4-904749EA93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70605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C2A0EA-36B1-42F2-A831-AFCC2032E692}" type="datetimeFigureOut">
              <a:rPr lang="en-GB" smtClean="0"/>
              <a:t>16/02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E2C32-EBFB-485C-92F4-904749EA93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7131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C2A0EA-36B1-42F2-A831-AFCC2032E692}" type="datetimeFigureOut">
              <a:rPr lang="en-GB" smtClean="0"/>
              <a:t>16/02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E2C32-EBFB-485C-92F4-904749EA93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98992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C2A0EA-36B1-42F2-A831-AFCC2032E692}" type="datetimeFigureOut">
              <a:rPr lang="en-GB" smtClean="0"/>
              <a:t>16/02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E2C32-EBFB-485C-92F4-904749EA93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31738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C2A0EA-36B1-42F2-A831-AFCC2032E692}" type="datetimeFigureOut">
              <a:rPr lang="en-GB" smtClean="0"/>
              <a:t>16/02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E2C32-EBFB-485C-92F4-904749EA93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89841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C2A0EA-36B1-42F2-A831-AFCC2032E692}" type="datetimeFigureOut">
              <a:rPr lang="en-GB" smtClean="0"/>
              <a:t>16/02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E2C32-EBFB-485C-92F4-904749EA93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90345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C2A0EA-36B1-42F2-A831-AFCC2032E692}" type="datetimeFigureOut">
              <a:rPr lang="en-GB" smtClean="0"/>
              <a:t>16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3E2C32-EBFB-485C-92F4-904749EA93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83518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4.png"/><Relationship Id="rId5" Type="http://schemas.openxmlformats.org/officeDocument/2006/relationships/image" Target="../media/image23.png"/><Relationship Id="rId4" Type="http://schemas.openxmlformats.org/officeDocument/2006/relationships/image" Target="../media/image2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8.png"/><Relationship Id="rId4" Type="http://schemas.openxmlformats.org/officeDocument/2006/relationships/image" Target="../media/image2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3.png"/><Relationship Id="rId5" Type="http://schemas.openxmlformats.org/officeDocument/2006/relationships/image" Target="../media/image32.png"/><Relationship Id="rId4" Type="http://schemas.openxmlformats.org/officeDocument/2006/relationships/image" Target="../media/image3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/>
          <a:srcRect t="22815" r="53944"/>
          <a:stretch/>
        </p:blipFill>
        <p:spPr>
          <a:xfrm>
            <a:off x="1875357" y="2011203"/>
            <a:ext cx="2590429" cy="1293759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/>
          <a:srcRect t="19068" r="52625"/>
          <a:stretch/>
        </p:blipFill>
        <p:spPr>
          <a:xfrm>
            <a:off x="1893334" y="3340213"/>
            <a:ext cx="2582414" cy="1129250"/>
          </a:xfrm>
          <a:prstGeom prst="rect">
            <a:avLst/>
          </a:prstGeom>
        </p:spPr>
      </p:pic>
      <p:grpSp>
        <p:nvGrpSpPr>
          <p:cNvPr id="16" name="Group 15"/>
          <p:cNvGrpSpPr>
            <a:grpSpLocks noChangeAspect="1"/>
          </p:cNvGrpSpPr>
          <p:nvPr/>
        </p:nvGrpSpPr>
        <p:grpSpPr>
          <a:xfrm>
            <a:off x="2436616" y="608929"/>
            <a:ext cx="2039132" cy="1367023"/>
            <a:chOff x="1023526" y="109141"/>
            <a:chExt cx="2272659" cy="1523577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4"/>
            <a:srcRect l="-1" r="59318"/>
            <a:stretch/>
          </p:blipFill>
          <p:spPr>
            <a:xfrm>
              <a:off x="1023526" y="155532"/>
              <a:ext cx="2272659" cy="1477186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1023526" y="109141"/>
              <a:ext cx="107105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/>
                <a:t>p</a:t>
              </a:r>
              <a:r>
                <a:rPr lang="en-GB" dirty="0" smtClean="0"/>
                <a:t>-ERK</a:t>
              </a:r>
              <a:endParaRPr lang="en-GB" dirty="0"/>
            </a:p>
          </p:txBody>
        </p:sp>
      </p:grpSp>
      <p:grpSp>
        <p:nvGrpSpPr>
          <p:cNvPr id="17" name="Group 16"/>
          <p:cNvGrpSpPr>
            <a:grpSpLocks noChangeAspect="1"/>
          </p:cNvGrpSpPr>
          <p:nvPr/>
        </p:nvGrpSpPr>
        <p:grpSpPr>
          <a:xfrm>
            <a:off x="2341893" y="5388192"/>
            <a:ext cx="2111441" cy="896431"/>
            <a:chOff x="746357" y="5269583"/>
            <a:chExt cx="2549828" cy="1082552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5"/>
            <a:srcRect r="58242"/>
            <a:stretch/>
          </p:blipFill>
          <p:spPr>
            <a:xfrm>
              <a:off x="746357" y="5269583"/>
              <a:ext cx="2549828" cy="1082552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>
              <a:off x="746357" y="5269583"/>
              <a:ext cx="117470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 smtClean="0"/>
                <a:t>IᴋB</a:t>
              </a:r>
              <a:r>
                <a:rPr lang="el-GR" dirty="0" smtClean="0"/>
                <a:t>α</a:t>
              </a:r>
              <a:endParaRPr lang="en-GB" dirty="0"/>
            </a:p>
          </p:txBody>
        </p:sp>
      </p:grpSp>
      <p:grpSp>
        <p:nvGrpSpPr>
          <p:cNvPr id="18" name="Group 17"/>
          <p:cNvGrpSpPr>
            <a:grpSpLocks noChangeAspect="1"/>
          </p:cNvGrpSpPr>
          <p:nvPr/>
        </p:nvGrpSpPr>
        <p:grpSpPr>
          <a:xfrm>
            <a:off x="2206358" y="4499026"/>
            <a:ext cx="2237504" cy="859603"/>
            <a:chOff x="3886199" y="5269583"/>
            <a:chExt cx="2618161" cy="1005839"/>
          </a:xfrm>
        </p:grpSpPr>
        <p:pic>
          <p:nvPicPr>
            <p:cNvPr id="10" name="Picture 9"/>
            <p:cNvPicPr>
              <a:picLocks noChangeAspect="1"/>
            </p:cNvPicPr>
            <p:nvPr/>
          </p:nvPicPr>
          <p:blipFill rotWithShape="1">
            <a:blip r:embed="rId6"/>
            <a:srcRect r="57123"/>
            <a:stretch/>
          </p:blipFill>
          <p:spPr>
            <a:xfrm>
              <a:off x="3886200" y="5269583"/>
              <a:ext cx="2618160" cy="1005839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>
              <a:off x="3886199" y="5269583"/>
              <a:ext cx="1608590" cy="4631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dirty="0" smtClean="0"/>
                <a:t>β</a:t>
              </a:r>
              <a:r>
                <a:rPr lang="en-GB" dirty="0" smtClean="0"/>
                <a:t>-catenin</a:t>
              </a:r>
              <a:endParaRPr lang="en-GB" dirty="0"/>
            </a:p>
          </p:txBody>
        </p:sp>
      </p:grpSp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7"/>
          <a:srcRect r="54227"/>
          <a:stretch/>
        </p:blipFill>
        <p:spPr>
          <a:xfrm>
            <a:off x="2221907" y="7257326"/>
            <a:ext cx="2243879" cy="1549139"/>
          </a:xfrm>
          <a:prstGeom prst="rect">
            <a:avLst/>
          </a:prstGeom>
        </p:spPr>
      </p:pic>
      <p:grpSp>
        <p:nvGrpSpPr>
          <p:cNvPr id="19" name="Group 18"/>
          <p:cNvGrpSpPr>
            <a:grpSpLocks noChangeAspect="1"/>
          </p:cNvGrpSpPr>
          <p:nvPr/>
        </p:nvGrpSpPr>
        <p:grpSpPr>
          <a:xfrm>
            <a:off x="2558940" y="6316029"/>
            <a:ext cx="1906846" cy="904286"/>
            <a:chOff x="3801611" y="6665201"/>
            <a:chExt cx="2444319" cy="1159173"/>
          </a:xfrm>
        </p:grpSpPr>
        <p:pic>
          <p:nvPicPr>
            <p:cNvPr id="14" name="Picture 13"/>
            <p:cNvPicPr>
              <a:picLocks noChangeAspect="1"/>
            </p:cNvPicPr>
            <p:nvPr/>
          </p:nvPicPr>
          <p:blipFill rotWithShape="1">
            <a:blip r:embed="rId8"/>
            <a:srcRect r="60119"/>
            <a:stretch/>
          </p:blipFill>
          <p:spPr>
            <a:xfrm>
              <a:off x="3801611" y="6665201"/>
              <a:ext cx="2444319" cy="1159173"/>
            </a:xfrm>
            <a:prstGeom prst="rect">
              <a:avLst/>
            </a:prstGeom>
          </p:spPr>
        </p:pic>
        <p:sp>
          <p:nvSpPr>
            <p:cNvPr id="15" name="TextBox 14"/>
            <p:cNvSpPr txBox="1"/>
            <p:nvPr/>
          </p:nvSpPr>
          <p:spPr>
            <a:xfrm>
              <a:off x="3801611" y="6665201"/>
              <a:ext cx="117470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 smtClean="0"/>
                <a:t>p-p65</a:t>
              </a:r>
              <a:endParaRPr lang="en-GB" dirty="0"/>
            </a:p>
          </p:txBody>
        </p:sp>
      </p:grpSp>
      <p:sp>
        <p:nvSpPr>
          <p:cNvPr id="20" name="TextBox 19"/>
          <p:cNvSpPr txBox="1"/>
          <p:nvPr/>
        </p:nvSpPr>
        <p:spPr>
          <a:xfrm>
            <a:off x="107640" y="648330"/>
            <a:ext cx="165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Figure 3A</a:t>
            </a:r>
            <a:endParaRPr lang="en-GB" dirty="0"/>
          </a:p>
        </p:txBody>
      </p:sp>
      <p:sp>
        <p:nvSpPr>
          <p:cNvPr id="2" name="Rectangle 1"/>
          <p:cNvSpPr/>
          <p:nvPr/>
        </p:nvSpPr>
        <p:spPr>
          <a:xfrm>
            <a:off x="107640" y="118327"/>
            <a:ext cx="5775801" cy="410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GB" b="1" kern="150" dirty="0"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Supplementary Info File 1. Uncropped/full length blots</a:t>
            </a:r>
            <a:endParaRPr lang="en-GB" kern="150" dirty="0">
              <a:latin typeface="Calibri" panose="020F0502020204030204" pitchFamily="34" charset="0"/>
              <a:ea typeface="SimSun" panose="02010600030101010101" pitchFamily="2" charset="-122"/>
              <a:cs typeface="Mangal"/>
            </a:endParaRP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045916" y="8843476"/>
            <a:ext cx="2419870" cy="10255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457644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53302" y="248645"/>
            <a:ext cx="4363278" cy="1418654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53302" y="1725791"/>
            <a:ext cx="3934802" cy="1427253"/>
          </a:xfrm>
          <a:prstGeom prst="rect">
            <a:avLst/>
          </a:prstGeom>
        </p:spPr>
      </p:pic>
      <p:grpSp>
        <p:nvGrpSpPr>
          <p:cNvPr id="13" name="Group 12"/>
          <p:cNvGrpSpPr>
            <a:grpSpLocks noChangeAspect="1"/>
          </p:cNvGrpSpPr>
          <p:nvPr/>
        </p:nvGrpSpPr>
        <p:grpSpPr>
          <a:xfrm>
            <a:off x="1620362" y="6580404"/>
            <a:ext cx="3829222" cy="1084905"/>
            <a:chOff x="167107" y="6863364"/>
            <a:chExt cx="4389962" cy="1243775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90501" y="6979746"/>
              <a:ext cx="4366568" cy="1127393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167107" y="6863364"/>
              <a:ext cx="973907" cy="4153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 smtClean="0"/>
                <a:t>HDAC6</a:t>
              </a:r>
              <a:endParaRPr lang="en-GB" dirty="0"/>
            </a:p>
          </p:txBody>
        </p:sp>
      </p:grpSp>
      <p:grpSp>
        <p:nvGrpSpPr>
          <p:cNvPr id="12" name="Group 11"/>
          <p:cNvGrpSpPr/>
          <p:nvPr/>
        </p:nvGrpSpPr>
        <p:grpSpPr>
          <a:xfrm>
            <a:off x="1911734" y="7714349"/>
            <a:ext cx="3432710" cy="753466"/>
            <a:chOff x="443820" y="8222591"/>
            <a:chExt cx="3926995" cy="985538"/>
          </a:xfrm>
        </p:grpSpPr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43820" y="8222591"/>
              <a:ext cx="3926995" cy="985538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>
              <a:off x="477210" y="8677725"/>
              <a:ext cx="1175764" cy="4594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 smtClean="0"/>
                <a:t>GAPDH</a:t>
              </a:r>
              <a:endParaRPr lang="en-GB" dirty="0"/>
            </a:p>
          </p:txBody>
        </p:sp>
      </p:grpSp>
      <p:grpSp>
        <p:nvGrpSpPr>
          <p:cNvPr id="15" name="Group 14"/>
          <p:cNvGrpSpPr>
            <a:grpSpLocks noChangeAspect="1"/>
          </p:cNvGrpSpPr>
          <p:nvPr/>
        </p:nvGrpSpPr>
        <p:grpSpPr>
          <a:xfrm>
            <a:off x="1817846" y="3067140"/>
            <a:ext cx="3677184" cy="1997637"/>
            <a:chOff x="301573" y="3691737"/>
            <a:chExt cx="4547603" cy="2486741"/>
          </a:xfrm>
        </p:grpSpPr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40205" y="3869248"/>
              <a:ext cx="4508971" cy="2309230"/>
            </a:xfrm>
            <a:prstGeom prst="rect">
              <a:avLst/>
            </a:prstGeom>
          </p:spPr>
        </p:pic>
        <p:sp>
          <p:nvSpPr>
            <p:cNvPr id="14" name="Rectangle 13"/>
            <p:cNvSpPr/>
            <p:nvPr/>
          </p:nvSpPr>
          <p:spPr>
            <a:xfrm>
              <a:off x="301573" y="3691737"/>
              <a:ext cx="657552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dirty="0"/>
                <a:t>p</a:t>
              </a:r>
              <a:r>
                <a:rPr lang="en-GB" dirty="0" smtClean="0"/>
                <a:t>-IᴋK</a:t>
              </a:r>
              <a:endParaRPr lang="en-GB" dirty="0"/>
            </a:p>
          </p:txBody>
        </p:sp>
      </p:grpSp>
      <p:grpSp>
        <p:nvGrpSpPr>
          <p:cNvPr id="17" name="Group 16"/>
          <p:cNvGrpSpPr>
            <a:grpSpLocks noChangeAspect="1"/>
          </p:cNvGrpSpPr>
          <p:nvPr/>
        </p:nvGrpSpPr>
        <p:grpSpPr>
          <a:xfrm>
            <a:off x="1804223" y="5140040"/>
            <a:ext cx="3647733" cy="1447912"/>
            <a:chOff x="4747044" y="5150052"/>
            <a:chExt cx="4609557" cy="1829694"/>
          </a:xfrm>
        </p:grpSpPr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747044" y="5150052"/>
              <a:ext cx="4609557" cy="1829694"/>
            </a:xfrm>
            <a:prstGeom prst="rect">
              <a:avLst/>
            </a:prstGeom>
          </p:spPr>
        </p:pic>
        <p:sp>
          <p:nvSpPr>
            <p:cNvPr id="16" name="Rectangle 15"/>
            <p:cNvSpPr/>
            <p:nvPr/>
          </p:nvSpPr>
          <p:spPr>
            <a:xfrm>
              <a:off x="4797397" y="5150052"/>
              <a:ext cx="793807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dirty="0" smtClean="0"/>
                <a:t>p-IᴋB</a:t>
              </a:r>
              <a:r>
                <a:rPr lang="el-GR" dirty="0"/>
                <a:t>α</a:t>
              </a:r>
              <a:endParaRPr lang="en-GB" dirty="0"/>
            </a:p>
          </p:txBody>
        </p:sp>
      </p:grpSp>
      <p:sp>
        <p:nvSpPr>
          <p:cNvPr id="18" name="TextBox 17"/>
          <p:cNvSpPr txBox="1"/>
          <p:nvPr/>
        </p:nvSpPr>
        <p:spPr>
          <a:xfrm>
            <a:off x="342900" y="292100"/>
            <a:ext cx="165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Figure 3B</a:t>
            </a:r>
            <a:endParaRPr lang="en-GB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8"/>
          <a:srcRect l="9213" r="6984"/>
          <a:stretch/>
        </p:blipFill>
        <p:spPr>
          <a:xfrm>
            <a:off x="1959356" y="8516855"/>
            <a:ext cx="3337465" cy="1306719"/>
          </a:xfrm>
          <a:prstGeom prst="rect">
            <a:avLst/>
          </a:prstGeom>
        </p:spPr>
      </p:pic>
      <p:sp>
        <p:nvSpPr>
          <p:cNvPr id="20" name="TextBox 19"/>
          <p:cNvSpPr txBox="1"/>
          <p:nvPr/>
        </p:nvSpPr>
        <p:spPr>
          <a:xfrm>
            <a:off x="1955984" y="8516855"/>
            <a:ext cx="1027772" cy="3512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GAPDH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5223720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>
            <a:grpSpLocks noChangeAspect="1"/>
          </p:cNvGrpSpPr>
          <p:nvPr/>
        </p:nvGrpSpPr>
        <p:grpSpPr>
          <a:xfrm>
            <a:off x="2333278" y="1079308"/>
            <a:ext cx="3650629" cy="1862207"/>
            <a:chOff x="394947" y="1472089"/>
            <a:chExt cx="3034053" cy="1547688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94947" y="1472089"/>
              <a:ext cx="3034053" cy="1547688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>
              <a:off x="394947" y="1472089"/>
              <a:ext cx="106810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 smtClean="0"/>
                <a:t>p65</a:t>
              </a:r>
              <a:endParaRPr lang="en-GB" dirty="0"/>
            </a:p>
          </p:txBody>
        </p:sp>
      </p:grpSp>
      <p:grpSp>
        <p:nvGrpSpPr>
          <p:cNvPr id="6" name="Group 5"/>
          <p:cNvGrpSpPr>
            <a:grpSpLocks noChangeAspect="1"/>
          </p:cNvGrpSpPr>
          <p:nvPr/>
        </p:nvGrpSpPr>
        <p:grpSpPr>
          <a:xfrm>
            <a:off x="2249054" y="3484924"/>
            <a:ext cx="3600000" cy="1233569"/>
            <a:chOff x="280023" y="5786403"/>
            <a:chExt cx="3263900" cy="1118399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80023" y="5786403"/>
              <a:ext cx="3263900" cy="1118399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>
              <a:off x="298691" y="5786403"/>
              <a:ext cx="106810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 err="1" smtClean="0"/>
                <a:t>Lamin</a:t>
              </a:r>
              <a:endParaRPr lang="en-GB" dirty="0"/>
            </a:p>
          </p:txBody>
        </p:sp>
      </p:grpSp>
      <p:pic>
        <p:nvPicPr>
          <p:cNvPr id="8" name="Picture 38"/>
          <p:cNvPicPr preferRelativeResize="0"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21727" y="3002250"/>
            <a:ext cx="2950141" cy="3747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" name="Picture 40"/>
          <p:cNvPicPr preferRelativeResize="0"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83811" y="621222"/>
            <a:ext cx="3088057" cy="3923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342900" y="292100"/>
            <a:ext cx="165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Figure 3D</a:t>
            </a:r>
            <a:endParaRPr lang="en-GB" dirty="0"/>
          </a:p>
        </p:txBody>
      </p:sp>
      <p:sp>
        <p:nvSpPr>
          <p:cNvPr id="11" name="Rectangle 10"/>
          <p:cNvSpPr/>
          <p:nvPr/>
        </p:nvSpPr>
        <p:spPr>
          <a:xfrm>
            <a:off x="1750918" y="644197"/>
            <a:ext cx="73289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 smtClean="0"/>
              <a:t>p-p65</a:t>
            </a:r>
            <a:endParaRPr lang="en-GB" dirty="0"/>
          </a:p>
        </p:txBody>
      </p:sp>
      <p:sp>
        <p:nvSpPr>
          <p:cNvPr id="12" name="Rectangle 11"/>
          <p:cNvSpPr/>
          <p:nvPr/>
        </p:nvSpPr>
        <p:spPr>
          <a:xfrm>
            <a:off x="1955456" y="3002250"/>
            <a:ext cx="54053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 smtClean="0"/>
              <a:t>p50</a:t>
            </a:r>
            <a:endParaRPr lang="en-GB" dirty="0"/>
          </a:p>
        </p:txBody>
      </p:sp>
      <p:sp>
        <p:nvSpPr>
          <p:cNvPr id="13" name="TextBox 12"/>
          <p:cNvSpPr txBox="1"/>
          <p:nvPr/>
        </p:nvSpPr>
        <p:spPr>
          <a:xfrm>
            <a:off x="7251700" y="944248"/>
            <a:ext cx="1193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/7/10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457243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32548" y="118905"/>
            <a:ext cx="3248526" cy="1964357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80678" y="2032526"/>
            <a:ext cx="3043254" cy="1440319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51964" y="5292162"/>
            <a:ext cx="3080982" cy="1939139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24266" y="7297274"/>
            <a:ext cx="3537281" cy="1894098"/>
          </a:xfrm>
          <a:prstGeom prst="rect">
            <a:avLst/>
          </a:prstGeom>
        </p:spPr>
      </p:pic>
      <p:grpSp>
        <p:nvGrpSpPr>
          <p:cNvPr id="9" name="Group 8"/>
          <p:cNvGrpSpPr/>
          <p:nvPr/>
        </p:nvGrpSpPr>
        <p:grpSpPr>
          <a:xfrm>
            <a:off x="1863996" y="3644532"/>
            <a:ext cx="3105046" cy="1647630"/>
            <a:chOff x="1863996" y="3644532"/>
            <a:chExt cx="3105046" cy="1647630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888060" y="3644532"/>
              <a:ext cx="3080982" cy="1647630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1863996" y="3644532"/>
              <a:ext cx="8659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 smtClean="0"/>
                <a:t>HDAC6</a:t>
              </a:r>
              <a:endParaRPr lang="en-GB" dirty="0"/>
            </a:p>
          </p:txBody>
        </p:sp>
      </p:grpSp>
      <p:sp>
        <p:nvSpPr>
          <p:cNvPr id="10" name="TextBox 9"/>
          <p:cNvSpPr txBox="1"/>
          <p:nvPr/>
        </p:nvSpPr>
        <p:spPr>
          <a:xfrm>
            <a:off x="342900" y="292100"/>
            <a:ext cx="165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Figure 4C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47124732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85327" y="5741978"/>
            <a:ext cx="3539727" cy="2346333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60905" y="3886794"/>
            <a:ext cx="3481123" cy="178829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53126" y="2031610"/>
            <a:ext cx="3455940" cy="1739771"/>
          </a:xfrm>
          <a:prstGeom prst="rect">
            <a:avLst/>
          </a:prstGeom>
        </p:spPr>
      </p:pic>
      <p:grpSp>
        <p:nvGrpSpPr>
          <p:cNvPr id="7" name="Group 6"/>
          <p:cNvGrpSpPr/>
          <p:nvPr/>
        </p:nvGrpSpPr>
        <p:grpSpPr>
          <a:xfrm>
            <a:off x="2265986" y="339263"/>
            <a:ext cx="3178410" cy="1576934"/>
            <a:chOff x="2265986" y="339263"/>
            <a:chExt cx="3178410" cy="1576934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265986" y="339263"/>
              <a:ext cx="3178410" cy="1576934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2619828" y="339263"/>
              <a:ext cx="1068102" cy="3358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 smtClean="0"/>
                <a:t>p-p65</a:t>
              </a:r>
              <a:endParaRPr lang="en-GB" dirty="0"/>
            </a:p>
          </p:txBody>
        </p:sp>
      </p:grpSp>
      <p:sp>
        <p:nvSpPr>
          <p:cNvPr id="8" name="TextBox 7"/>
          <p:cNvSpPr txBox="1"/>
          <p:nvPr/>
        </p:nvSpPr>
        <p:spPr>
          <a:xfrm>
            <a:off x="342900" y="292100"/>
            <a:ext cx="165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Figure 4D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864881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04862" y="1606346"/>
            <a:ext cx="869896" cy="1413581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04921" y="3152274"/>
            <a:ext cx="869837" cy="1473606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04862" y="4758227"/>
            <a:ext cx="869896" cy="1474681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04862" y="6364180"/>
            <a:ext cx="883842" cy="854768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704863" y="7350220"/>
            <a:ext cx="869896" cy="544701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1704862" y="1606346"/>
            <a:ext cx="14478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/>
              <a:t>Ac-H3 (Lys9)</a:t>
            </a:r>
            <a:endParaRPr lang="en-GB" sz="1000" dirty="0"/>
          </a:p>
        </p:txBody>
      </p:sp>
      <p:sp>
        <p:nvSpPr>
          <p:cNvPr id="13" name="TextBox 12"/>
          <p:cNvSpPr txBox="1"/>
          <p:nvPr/>
        </p:nvSpPr>
        <p:spPr>
          <a:xfrm>
            <a:off x="1704862" y="3151199"/>
            <a:ext cx="14478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/>
              <a:t>Ac-H3 (Lys23)</a:t>
            </a:r>
            <a:endParaRPr lang="en-GB" sz="1000" dirty="0"/>
          </a:p>
        </p:txBody>
      </p:sp>
      <p:sp>
        <p:nvSpPr>
          <p:cNvPr id="14" name="TextBox 13"/>
          <p:cNvSpPr txBox="1"/>
          <p:nvPr/>
        </p:nvSpPr>
        <p:spPr>
          <a:xfrm>
            <a:off x="1704861" y="4757152"/>
            <a:ext cx="14478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/>
              <a:t>Ac-</a:t>
            </a:r>
            <a:r>
              <a:rPr lang="el-GR" sz="1000" dirty="0" smtClean="0"/>
              <a:t>α</a:t>
            </a:r>
            <a:r>
              <a:rPr lang="en-GB" sz="1000" dirty="0" smtClean="0"/>
              <a:t>-tubulin</a:t>
            </a:r>
            <a:endParaRPr lang="en-GB" sz="1000" dirty="0"/>
          </a:p>
        </p:txBody>
      </p:sp>
      <p:sp>
        <p:nvSpPr>
          <p:cNvPr id="15" name="TextBox 14"/>
          <p:cNvSpPr txBox="1"/>
          <p:nvPr/>
        </p:nvSpPr>
        <p:spPr>
          <a:xfrm>
            <a:off x="1126957" y="6363105"/>
            <a:ext cx="14478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/>
              <a:t>HDAC6</a:t>
            </a:r>
            <a:endParaRPr lang="en-GB" sz="1000" dirty="0"/>
          </a:p>
        </p:txBody>
      </p:sp>
      <p:sp>
        <p:nvSpPr>
          <p:cNvPr id="16" name="TextBox 15"/>
          <p:cNvSpPr txBox="1"/>
          <p:nvPr/>
        </p:nvSpPr>
        <p:spPr>
          <a:xfrm>
            <a:off x="1140903" y="7345344"/>
            <a:ext cx="14478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/>
              <a:t>GAPDH</a:t>
            </a:r>
            <a:endParaRPr lang="en-GB" sz="1000" dirty="0"/>
          </a:p>
        </p:txBody>
      </p:sp>
      <p:sp>
        <p:nvSpPr>
          <p:cNvPr id="17" name="TextBox 16"/>
          <p:cNvSpPr txBox="1"/>
          <p:nvPr/>
        </p:nvSpPr>
        <p:spPr>
          <a:xfrm>
            <a:off x="342900" y="292100"/>
            <a:ext cx="2677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Supplementary Figure 2 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4214738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220</TotalTime>
  <Words>53</Words>
  <Application>Microsoft Office PowerPoint</Application>
  <PresentationFormat>A4 Paper (210x297 mm)</PresentationFormat>
  <Paragraphs>28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SimSun</vt:lpstr>
      <vt:lpstr>Arial</vt:lpstr>
      <vt:lpstr>Calibri</vt:lpstr>
      <vt:lpstr>Calibri Light</vt:lpstr>
      <vt:lpstr>Mang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Newcastle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t Barter</dc:creator>
  <cp:lastModifiedBy>Matt Barter</cp:lastModifiedBy>
  <cp:revision>39</cp:revision>
  <dcterms:created xsi:type="dcterms:W3CDTF">2021-11-04T13:16:57Z</dcterms:created>
  <dcterms:modified xsi:type="dcterms:W3CDTF">2022-02-16T15:48:59Z</dcterms:modified>
</cp:coreProperties>
</file>